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0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463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849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09253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198727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482115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109021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285728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101686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788667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129962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9018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04032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590870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387460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9893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83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675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899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916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200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232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599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894DC1-C9B0-4D4F-A1FA-C2C5C3E55F83}" type="datetimeFigureOut">
              <a:rPr lang="en-US" smtClean="0"/>
              <a:t>11/21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1C2E3C-C405-4E07-87EB-E25EFAE43D1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13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B0C78-3BE5-4D76-AFCE-7A9D02EFEF8D}" type="datetimeFigureOut">
              <a:rPr lang="de-DE" smtClean="0"/>
              <a:t>21.11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B67196-0209-443B-8734-A9A4AE15711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945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9649" y="2091296"/>
            <a:ext cx="2236656" cy="365689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1944" y="2091296"/>
            <a:ext cx="2547833" cy="3656890"/>
          </a:xfrm>
          <a:prstGeom prst="rect">
            <a:avLst/>
          </a:prstGeom>
        </p:spPr>
      </p:pic>
      <p:sp>
        <p:nvSpPr>
          <p:cNvPr id="21" name="Textfeld 20"/>
          <p:cNvSpPr txBox="1"/>
          <p:nvPr/>
        </p:nvSpPr>
        <p:spPr>
          <a:xfrm>
            <a:off x="699796" y="550506"/>
            <a:ext cx="8121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P vom 06.06.23 CX 8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eeks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.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ntibody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used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or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IP: GCP2 (MERCK). AP2a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or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</a:t>
            </a: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IP (BD)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2257803" y="5748186"/>
            <a:ext cx="1002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5.06.23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4766878" y="5748186"/>
            <a:ext cx="1002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0.07.23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7269365" y="3781466"/>
            <a:ext cx="845605" cy="4968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P2</a:t>
            </a:r>
            <a:r>
              <a:rPr kumimoji="0" lang="el-G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α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9" name="Gerader Verbinder 8"/>
          <p:cNvCxnSpPr/>
          <p:nvPr/>
        </p:nvCxnSpPr>
        <p:spPr>
          <a:xfrm flipV="1">
            <a:off x="9531474" y="3476399"/>
            <a:ext cx="272101" cy="20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feld 9"/>
          <p:cNvSpPr txBox="1"/>
          <p:nvPr/>
        </p:nvSpPr>
        <p:spPr>
          <a:xfrm>
            <a:off x="9751407" y="3323409"/>
            <a:ext cx="813934" cy="3726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00kDa</a:t>
            </a:r>
          </a:p>
        </p:txBody>
      </p:sp>
      <p:sp>
        <p:nvSpPr>
          <p:cNvPr id="12" name="Textfeld 11"/>
          <p:cNvSpPr txBox="1"/>
          <p:nvPr/>
        </p:nvSpPr>
        <p:spPr>
          <a:xfrm rot="18819328">
            <a:off x="7907289" y="2538915"/>
            <a:ext cx="957958" cy="3420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put CX</a:t>
            </a:r>
          </a:p>
        </p:txBody>
      </p:sp>
      <p:sp>
        <p:nvSpPr>
          <p:cNvPr id="13" name="Textfeld 12"/>
          <p:cNvSpPr txBox="1"/>
          <p:nvPr/>
        </p:nvSpPr>
        <p:spPr>
          <a:xfrm rot="18819328">
            <a:off x="8549088" y="2607903"/>
            <a:ext cx="528796" cy="3420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gG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" name="Textfeld 13"/>
          <p:cNvSpPr txBox="1"/>
          <p:nvPr/>
        </p:nvSpPr>
        <p:spPr>
          <a:xfrm rot="18819328">
            <a:off x="8759511" y="2333033"/>
            <a:ext cx="1614856" cy="34204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CP2 IP (Merck)</a:t>
            </a:r>
          </a:p>
        </p:txBody>
      </p:sp>
      <p:cxnSp>
        <p:nvCxnSpPr>
          <p:cNvPr id="16" name="Gerader Verbinder 15"/>
          <p:cNvCxnSpPr/>
          <p:nvPr/>
        </p:nvCxnSpPr>
        <p:spPr>
          <a:xfrm flipV="1">
            <a:off x="9536596" y="4146911"/>
            <a:ext cx="272101" cy="20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/>
          <p:cNvSpPr txBox="1"/>
          <p:nvPr/>
        </p:nvSpPr>
        <p:spPr>
          <a:xfrm>
            <a:off x="9751407" y="4029905"/>
            <a:ext cx="813934" cy="3726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00kDa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7269365" y="3192130"/>
            <a:ext cx="851543" cy="4968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CP2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919209" y="3781466"/>
            <a:ext cx="1610279" cy="4273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959050" y="3120647"/>
            <a:ext cx="1570438" cy="5359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Textfeld 25"/>
          <p:cNvSpPr txBox="1"/>
          <p:nvPr/>
        </p:nvSpPr>
        <p:spPr>
          <a:xfrm>
            <a:off x="8234353" y="4278345"/>
            <a:ext cx="1019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put 1%</a:t>
            </a:r>
            <a:endParaRPr kumimoji="0" lang="de-DE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6265660" y="2469571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P2</a:t>
            </a:r>
            <a:r>
              <a:rPr kumimoji="0" lang="el-G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α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9" name="Textfeld 28"/>
          <p:cNvSpPr txBox="1"/>
          <p:nvPr/>
        </p:nvSpPr>
        <p:spPr>
          <a:xfrm rot="18968415">
            <a:off x="4628796" y="1690267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nput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0" name="Textfeld 29"/>
          <p:cNvSpPr txBox="1"/>
          <p:nvPr/>
        </p:nvSpPr>
        <p:spPr>
          <a:xfrm rot="18968415">
            <a:off x="5308931" y="1690268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gG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1" name="Textfeld 30"/>
          <p:cNvSpPr txBox="1"/>
          <p:nvPr/>
        </p:nvSpPr>
        <p:spPr>
          <a:xfrm rot="18758778">
            <a:off x="5756729" y="1588778"/>
            <a:ext cx="918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CP2 IP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4590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</Words>
  <Application>Microsoft Office PowerPoint</Application>
  <PresentationFormat>Breitbild</PresentationFormat>
  <Paragraphs>1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2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1_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ononenko PC 6</dc:creator>
  <cp:lastModifiedBy>Kononenko PC 6</cp:lastModifiedBy>
  <cp:revision>2</cp:revision>
  <dcterms:created xsi:type="dcterms:W3CDTF">2023-11-21T13:25:52Z</dcterms:created>
  <dcterms:modified xsi:type="dcterms:W3CDTF">2023-11-21T13:37:06Z</dcterms:modified>
</cp:coreProperties>
</file>